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06A52F2-FB65-45B3-BF56-8E66D0519179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93306D5-D0FA-4060-8FD7-482C40517A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7587160-8447-4E52-B070-08D0601042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90C241E-4725-42CA-A622-249562701C10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8419BBD-B809-4731-B46D-FABD372920AD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76ECA8B9-66E8-461E-B073-56141D5AA1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7CDF50CB-278E-470C-B8C5-B7854539AD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31177F6D-53AC-48F3-89EC-89BAAE94C0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75AE955-4A72-4EBE-908C-A93E577801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560B434-5E5E-4B08-BF6D-FAC3D5124F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ED29661F-E0D3-4409-8AD1-A337777B49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2810D96-9D69-4D6F-B0E2-50DE3AB7C8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8E98F518-726B-4F49-84E0-29438E7098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6A8D485F-45D6-45A6-99AA-9AA482D200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EA7B4A7A-094B-474F-9E0F-04E188B844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7AEA8AD2-9643-4088-A236-6D367501DF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DA3E178-33A1-40FF-B0BC-AB377BA43AC9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0958DDB-EBD5-41EF-B3F8-BE0293EBF9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F681FD4-B5DE-47A0-9489-FCE26E4720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56B28D5-2D18-4F96-99C0-7492B1D29B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CEE0837-5F13-4F19-BC12-36ECC5AF5C9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6990DED-C164-49D2-81F3-AFCEA8EFC7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76FE24E-83F2-4A81-9433-24DA09E2BE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751A026-BEB7-4CAF-BA90-43A2B0EC51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 idx="1"/>
          </p:nvPr>
        </p:nvSpPr>
        <p:spPr>
          <a:xfrm>
            <a:off x="457200" y="6356160"/>
            <a:ext cx="213192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2/15/17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sldNum" idx="2"/>
          </p:nvPr>
        </p:nvSpPr>
        <p:spPr>
          <a:xfrm>
            <a:off x="6552720" y="6356160"/>
            <a:ext cx="213228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1DEE4035-8F13-4F3C-979D-7EB990B7B834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99000"/>
          </a:bodyPr>
          <a:p>
            <a:pPr marL="3394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 fontScale="96000"/>
          </a:bodyPr>
          <a:p>
            <a:pPr marL="32904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3"/>
          </p:nvPr>
        </p:nvSpPr>
        <p:spPr>
          <a:xfrm>
            <a:off x="457200" y="6356160"/>
            <a:ext cx="213192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2/15/17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sldNum" idx="4"/>
          </p:nvPr>
        </p:nvSpPr>
        <p:spPr>
          <a:xfrm>
            <a:off x="6552720" y="6356160"/>
            <a:ext cx="213228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42FA6023-6F66-4024-BF06-DAF7867FA3F5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"/>
          <p:cNvSpPr/>
          <p:nvPr/>
        </p:nvSpPr>
        <p:spPr>
          <a:xfrm>
            <a:off x="38160" y="12600"/>
            <a:ext cx="910584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. 1  The distribution of concentrations of B2M in all 1,762 subject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3" name=""/>
          <p:cNvGrpSpPr/>
          <p:nvPr/>
        </p:nvGrpSpPr>
        <p:grpSpPr>
          <a:xfrm>
            <a:off x="700200" y="712800"/>
            <a:ext cx="7016760" cy="4663440"/>
            <a:chOff x="700200" y="712800"/>
            <a:chExt cx="7016760" cy="4663440"/>
          </a:xfrm>
        </p:grpSpPr>
        <p:pic>
          <p:nvPicPr>
            <p:cNvPr id="84" name="" descr=""/>
            <p:cNvPicPr/>
            <p:nvPr/>
          </p:nvPicPr>
          <p:blipFill>
            <a:blip r:embed="rId1"/>
            <a:stretch/>
          </p:blipFill>
          <p:spPr>
            <a:xfrm>
              <a:off x="1346040" y="1638360"/>
              <a:ext cx="6159600" cy="32004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5" name=""/>
            <p:cNvGrpSpPr/>
            <p:nvPr/>
          </p:nvGrpSpPr>
          <p:grpSpPr>
            <a:xfrm>
              <a:off x="700200" y="712800"/>
              <a:ext cx="7016760" cy="4663440"/>
              <a:chOff x="700200" y="712800"/>
              <a:chExt cx="7016760" cy="4663440"/>
            </a:xfrm>
          </p:grpSpPr>
          <p:grpSp>
            <p:nvGrpSpPr>
              <p:cNvPr id="86" name=""/>
              <p:cNvGrpSpPr/>
              <p:nvPr/>
            </p:nvGrpSpPr>
            <p:grpSpPr>
              <a:xfrm>
                <a:off x="700200" y="712800"/>
                <a:ext cx="7016760" cy="4358520"/>
                <a:chOff x="700200" y="712800"/>
                <a:chExt cx="7016760" cy="4358520"/>
              </a:xfrm>
            </p:grpSpPr>
            <p:grpSp>
              <p:nvGrpSpPr>
                <p:cNvPr id="87" name=""/>
                <p:cNvGrpSpPr/>
                <p:nvPr/>
              </p:nvGrpSpPr>
              <p:grpSpPr>
                <a:xfrm>
                  <a:off x="1418760" y="1474920"/>
                  <a:ext cx="6298200" cy="3596400"/>
                  <a:chOff x="1418760" y="1474920"/>
                  <a:chExt cx="6298200" cy="3596400"/>
                </a:xfrm>
              </p:grpSpPr>
              <p:grpSp>
                <p:nvGrpSpPr>
                  <p:cNvPr id="88" name=""/>
                  <p:cNvGrpSpPr/>
                  <p:nvPr/>
                </p:nvGrpSpPr>
                <p:grpSpPr>
                  <a:xfrm>
                    <a:off x="1756080" y="4659480"/>
                    <a:ext cx="5960880" cy="411840"/>
                    <a:chOff x="1756080" y="4659480"/>
                    <a:chExt cx="5960880" cy="411840"/>
                  </a:xfrm>
                </p:grpSpPr>
                <p:sp>
                  <p:nvSpPr>
                    <p:cNvPr id="89" name=""/>
                    <p:cNvSpPr/>
                    <p:nvPr/>
                  </p:nvSpPr>
                  <p:spPr>
                    <a:xfrm>
                      <a:off x="1756080" y="4659480"/>
                      <a:ext cx="299520" cy="411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tIns="9144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0" name=""/>
                    <p:cNvSpPr/>
                    <p:nvPr/>
                  </p:nvSpPr>
                  <p:spPr>
                    <a:xfrm>
                      <a:off x="2611440" y="4659480"/>
                      <a:ext cx="476280" cy="411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tIns="9144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1" name=""/>
                    <p:cNvSpPr/>
                    <p:nvPr/>
                  </p:nvSpPr>
                  <p:spPr>
                    <a:xfrm>
                      <a:off x="3540240" y="4659480"/>
                      <a:ext cx="476280" cy="411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tIns="9144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" name=""/>
                    <p:cNvSpPr/>
                    <p:nvPr/>
                  </p:nvSpPr>
                  <p:spPr>
                    <a:xfrm>
                      <a:off x="4456080" y="4659480"/>
                      <a:ext cx="476280" cy="411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tIns="9144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5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" name=""/>
                    <p:cNvSpPr/>
                    <p:nvPr/>
                  </p:nvSpPr>
                  <p:spPr>
                    <a:xfrm>
                      <a:off x="5369040" y="4659480"/>
                      <a:ext cx="476280" cy="411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tIns="9144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" name=""/>
                    <p:cNvSpPr/>
                    <p:nvPr/>
                  </p:nvSpPr>
                  <p:spPr>
                    <a:xfrm>
                      <a:off x="6307200" y="4659480"/>
                      <a:ext cx="476280" cy="411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tIns="9144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5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" name=""/>
                    <p:cNvSpPr/>
                    <p:nvPr/>
                  </p:nvSpPr>
                  <p:spPr>
                    <a:xfrm>
                      <a:off x="7240680" y="4659480"/>
                      <a:ext cx="476280" cy="411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tIns="9144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96" name=""/>
                  <p:cNvGrpSpPr/>
                  <p:nvPr/>
                </p:nvGrpSpPr>
                <p:grpSpPr>
                  <a:xfrm>
                    <a:off x="1418760" y="1474920"/>
                    <a:ext cx="531000" cy="3437640"/>
                    <a:chOff x="1418760" y="1474920"/>
                    <a:chExt cx="531000" cy="3437640"/>
                  </a:xfrm>
                </p:grpSpPr>
                <p:sp>
                  <p:nvSpPr>
                    <p:cNvPr id="97" name=""/>
                    <p:cNvSpPr/>
                    <p:nvPr/>
                  </p:nvSpPr>
                  <p:spPr>
                    <a:xfrm>
                      <a:off x="1418760" y="1474920"/>
                      <a:ext cx="531000" cy="411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tIns="9144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2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" name=""/>
                    <p:cNvSpPr/>
                    <p:nvPr/>
                  </p:nvSpPr>
                  <p:spPr>
                    <a:xfrm>
                      <a:off x="1418760" y="2232000"/>
                      <a:ext cx="531000" cy="411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tIns="9144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9" name=""/>
                    <p:cNvSpPr/>
                    <p:nvPr/>
                  </p:nvSpPr>
                  <p:spPr>
                    <a:xfrm>
                      <a:off x="1418760" y="2987640"/>
                      <a:ext cx="531000" cy="411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tIns="9144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0" name=""/>
                    <p:cNvSpPr/>
                    <p:nvPr/>
                  </p:nvSpPr>
                  <p:spPr>
                    <a:xfrm>
                      <a:off x="1643400" y="4500720"/>
                      <a:ext cx="299520" cy="411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tIns="9144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" name=""/>
                    <p:cNvSpPr/>
                    <p:nvPr/>
                  </p:nvSpPr>
                  <p:spPr>
                    <a:xfrm>
                      <a:off x="1530000" y="3745080"/>
                      <a:ext cx="415080" cy="411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tIns="9144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sp>
              <p:nvSpPr>
                <p:cNvPr id="102" name=""/>
                <p:cNvSpPr/>
                <p:nvPr/>
              </p:nvSpPr>
              <p:spPr>
                <a:xfrm>
                  <a:off x="3757680" y="1255680"/>
                  <a:ext cx="1440" cy="3440160"/>
                </a:xfrm>
                <a:prstGeom prst="line">
                  <a:avLst/>
                </a:prstGeom>
                <a:ln w="19080">
                  <a:solidFill>
                    <a:srgbClr val="7030a0"/>
                  </a:solidFill>
                  <a:prstDash val="lgDash"/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93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"/>
                <p:cNvSpPr/>
                <p:nvPr/>
              </p:nvSpPr>
              <p:spPr>
                <a:xfrm>
                  <a:off x="4084560" y="1255680"/>
                  <a:ext cx="1800" cy="3440160"/>
                </a:xfrm>
                <a:prstGeom prst="line">
                  <a:avLst/>
                </a:prstGeom>
                <a:ln w="19080">
                  <a:solidFill>
                    <a:srgbClr val="7030a0"/>
                  </a:solidFill>
                  <a:prstDash val="lgDash"/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93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"/>
                <p:cNvSpPr/>
                <p:nvPr/>
              </p:nvSpPr>
              <p:spPr>
                <a:xfrm>
                  <a:off x="4414680" y="1255680"/>
                  <a:ext cx="1800" cy="3440160"/>
                </a:xfrm>
                <a:prstGeom prst="line">
                  <a:avLst/>
                </a:prstGeom>
                <a:ln w="19080">
                  <a:solidFill>
                    <a:srgbClr val="7030a0"/>
                  </a:solidFill>
                  <a:prstDash val="lgDash"/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93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105" name=""/>
                <p:cNvCxnSpPr/>
                <p:nvPr/>
              </p:nvCxnSpPr>
              <p:spPr>
                <a:xfrm>
                  <a:off x="3405240" y="1371600"/>
                  <a:ext cx="340200" cy="2160"/>
                </a:xfrm>
                <a:prstGeom prst="bentConnector3">
                  <a:avLst>
                    <a:gd name="adj1" fmla="val 50000"/>
                  </a:avLst>
                </a:prstGeom>
                <a:ln w="19080">
                  <a:solidFill>
                    <a:srgbClr val="000000"/>
                  </a:solidFill>
                  <a:round/>
                  <a:headEnd len="med" type="triangle" w="med"/>
                  <a:tailEnd len="med" type="triangle" w="med"/>
                </a:ln>
              </p:spPr>
            </p:cxnSp>
            <p:cxnSp>
              <p:nvCxnSpPr>
                <p:cNvPr id="106" name=""/>
                <p:cNvCxnSpPr/>
                <p:nvPr/>
              </p:nvCxnSpPr>
              <p:spPr>
                <a:xfrm>
                  <a:off x="3735360" y="1561680"/>
                  <a:ext cx="340200" cy="2520"/>
                </a:xfrm>
                <a:prstGeom prst="bentConnector3">
                  <a:avLst>
                    <a:gd name="adj1" fmla="val 50000"/>
                  </a:avLst>
                </a:prstGeom>
                <a:ln w="19080">
                  <a:solidFill>
                    <a:srgbClr val="000000"/>
                  </a:solidFill>
                  <a:round/>
                  <a:headEnd len="med" type="triangle" w="med"/>
                  <a:tailEnd len="med" type="triangle" w="med"/>
                </a:ln>
              </p:spPr>
            </p:cxnSp>
            <p:cxnSp>
              <p:nvCxnSpPr>
                <p:cNvPr id="107" name=""/>
                <p:cNvCxnSpPr/>
                <p:nvPr/>
              </p:nvCxnSpPr>
              <p:spPr>
                <a:xfrm>
                  <a:off x="700200" y="1974960"/>
                  <a:ext cx="1521360" cy="2160"/>
                </a:xfrm>
                <a:prstGeom prst="bentConnector3">
                  <a:avLst>
                    <a:gd name="adj1" fmla="val 49988"/>
                  </a:avLst>
                </a:prstGeom>
                <a:ln w="19080">
                  <a:solidFill>
                    <a:srgbClr val="000000"/>
                  </a:solidFill>
                  <a:round/>
                  <a:headEnd len="med" type="triangle" w="med"/>
                  <a:tailEnd len="med" type="triangle" w="med"/>
                </a:ln>
              </p:spPr>
            </p:cxnSp>
            <p:sp>
              <p:nvSpPr>
                <p:cNvPr id="108" name=""/>
                <p:cNvSpPr/>
                <p:nvPr/>
              </p:nvSpPr>
              <p:spPr>
                <a:xfrm>
                  <a:off x="2426400" y="1500120"/>
                  <a:ext cx="1078200" cy="563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tIns="9144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72396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  <a:tab algn="l" pos="96012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Calibri"/>
                    </a:rPr>
                    <a:t>1st Quartile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72396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  <a:tab algn="l" pos="96012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Calibri"/>
                    </a:rPr>
                    <a:t>≤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Calibri"/>
                    </a:rPr>
                    <a:t>1.00(mg/L)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>
                  <a:off x="2671200" y="712800"/>
                  <a:ext cx="1361520" cy="563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tIns="9144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72396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  <a:tab algn="l" pos="96012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Calibri"/>
                    </a:rPr>
                    <a:t>2nd Quartile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72396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  <a:tab algn="l" pos="96012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Calibri"/>
                    </a:rPr>
                    <a:t>1.00-1.17(mg/L)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110" name=""/>
                <p:cNvCxnSpPr/>
                <p:nvPr/>
              </p:nvCxnSpPr>
              <p:spPr>
                <a:xfrm>
                  <a:off x="1719000" y="1195560"/>
                  <a:ext cx="1099080" cy="2160"/>
                </a:xfrm>
                <a:prstGeom prst="bentConnector3">
                  <a:avLst>
                    <a:gd name="adj1" fmla="val 50000"/>
                  </a:avLst>
                </a:prstGeom>
                <a:ln w="19080">
                  <a:solidFill>
                    <a:srgbClr val="000000"/>
                  </a:solidFill>
                  <a:round/>
                </a:ln>
              </p:spPr>
            </p:cxnSp>
            <p:cxnSp>
              <p:nvCxnSpPr>
                <p:cNvPr id="111" name=""/>
                <p:cNvCxnSpPr/>
                <p:nvPr/>
              </p:nvCxnSpPr>
              <p:spPr>
                <a:xfrm flipV="1">
                  <a:off x="3906360" y="1007280"/>
                  <a:ext cx="2520" cy="183240"/>
                </a:xfrm>
                <a:prstGeom prst="bentConnector3">
                  <a:avLst>
                    <a:gd name="adj1" fmla="val 50000"/>
                  </a:avLst>
                </a:prstGeom>
                <a:ln w="19080">
                  <a:solidFill>
                    <a:srgbClr val="000000"/>
                  </a:solidFill>
                  <a:round/>
                </a:ln>
              </p:spPr>
            </p:cxnSp>
            <p:sp>
              <p:nvSpPr>
                <p:cNvPr id="112" name=""/>
                <p:cNvSpPr/>
                <p:nvPr/>
              </p:nvSpPr>
              <p:spPr>
                <a:xfrm>
                  <a:off x="4068000" y="723960"/>
                  <a:ext cx="1361520" cy="563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tIns="9144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72396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  <a:tab algn="l" pos="96012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Calibri"/>
                    </a:rPr>
                    <a:t>3rd Quartile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72396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  <a:tab algn="l" pos="96012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Calibri"/>
                    </a:rPr>
                    <a:t>1.18-1.35(mg/L)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113" name=""/>
                <p:cNvCxnSpPr/>
                <p:nvPr/>
              </p:nvCxnSpPr>
              <p:spPr>
                <a:xfrm>
                  <a:off x="3152520" y="1198080"/>
                  <a:ext cx="1099080" cy="2520"/>
                </a:xfrm>
                <a:prstGeom prst="bentConnector3">
                  <a:avLst>
                    <a:gd name="adj1" fmla="val 50000"/>
                  </a:avLst>
                </a:prstGeom>
                <a:ln w="19080">
                  <a:solidFill>
                    <a:srgbClr val="000000"/>
                  </a:solidFill>
                  <a:round/>
                </a:ln>
              </p:spPr>
            </p:cxnSp>
            <p:cxnSp>
              <p:nvCxnSpPr>
                <p:cNvPr id="114" name=""/>
                <p:cNvCxnSpPr/>
                <p:nvPr/>
              </p:nvCxnSpPr>
              <p:spPr>
                <a:xfrm flipV="1">
                  <a:off x="4253040" y="824760"/>
                  <a:ext cx="2160" cy="367560"/>
                </a:xfrm>
                <a:prstGeom prst="bentConnector3">
                  <a:avLst>
                    <a:gd name="adj1" fmla="val 40000"/>
                  </a:avLst>
                </a:prstGeom>
                <a:ln w="19080">
                  <a:solidFill>
                    <a:srgbClr val="000000"/>
                  </a:solidFill>
                  <a:round/>
                </a:ln>
              </p:spPr>
            </p:cxnSp>
            <p:cxnSp>
              <p:nvCxnSpPr>
                <p:cNvPr id="115" name=""/>
                <p:cNvCxnSpPr/>
                <p:nvPr/>
              </p:nvCxnSpPr>
              <p:spPr>
                <a:xfrm>
                  <a:off x="1293840" y="1974960"/>
                  <a:ext cx="3123360" cy="2160"/>
                </a:xfrm>
                <a:prstGeom prst="bentConnector3">
                  <a:avLst>
                    <a:gd name="adj1" fmla="val 49994"/>
                  </a:avLst>
                </a:prstGeom>
                <a:ln w="19080">
                  <a:solidFill>
                    <a:srgbClr val="000000"/>
                  </a:solidFill>
                  <a:round/>
                  <a:headEnd len="med" type="triangle" w="med"/>
                  <a:tailEnd len="med" type="triangle" w="med"/>
                </a:ln>
              </p:spPr>
            </p:cxnSp>
            <p:sp>
              <p:nvSpPr>
                <p:cNvPr id="116" name=""/>
                <p:cNvSpPr/>
                <p:nvPr/>
              </p:nvSpPr>
              <p:spPr>
                <a:xfrm>
                  <a:off x="5430600" y="1461960"/>
                  <a:ext cx="1079640" cy="563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tIns="9144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72396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  <a:tab algn="l" pos="96012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Calibri"/>
                    </a:rPr>
                    <a:t>4th Quartile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72396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  <a:tab algn="l" pos="96012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Calibri"/>
                    </a:rPr>
                    <a:t>&gt;1.35(mg/L)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7" name=""/>
              <p:cNvSpPr/>
              <p:nvPr/>
            </p:nvSpPr>
            <p:spPr>
              <a:xfrm>
                <a:off x="2859840" y="4933800"/>
                <a:ext cx="2824560" cy="442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t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1447920"/>
                    <a:tab algn="l" pos="217188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  <a:tab algn="l" pos="10058400"/>
                    <a:tab algn="l" pos="10515600"/>
                  </a:tabLst>
                </a:pPr>
                <a:r>
                  <a:rPr b="1" lang="en-US" sz="2000" spc="-1" strike="noStrike">
                    <a:solidFill>
                      <a:srgbClr val="000000"/>
                    </a:solidFill>
                    <a:latin typeface="Calibri"/>
                  </a:rPr>
                  <a:t>β2-Microglobulin (mg/L) 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 rot="16200000">
                <a:off x="470520" y="3041280"/>
                <a:ext cx="1587240" cy="442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t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144792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  <a:tab algn="l" pos="10058400"/>
                    <a:tab algn="l" pos="10515600"/>
                  </a:tabLst>
                </a:pPr>
                <a:r>
                  <a:rPr b="1" lang="en-US" sz="2000" spc="-1" strike="noStrike">
                    <a:solidFill>
                      <a:srgbClr val="000000"/>
                    </a:solidFill>
                    <a:latin typeface="Calibri"/>
                  </a:rPr>
                  <a:t># of Subjects 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